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3" d="100"/>
          <a:sy n="83" d="100"/>
        </p:scale>
        <p:origin x="1387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PAEFTHYMIOU MARIA" userId="9fc4bb3a-9f47-4932-b338-1082eb2e432c" providerId="ADAL" clId="{FFA22E30-4287-4D00-8F16-F4B4690408A8}"/>
    <pc:docChg chg="undo custSel modSld">
      <pc:chgData name="PAPAEFTHYMIOU MARIA" userId="9fc4bb3a-9f47-4932-b338-1082eb2e432c" providerId="ADAL" clId="{FFA22E30-4287-4D00-8F16-F4B4690408A8}" dt="2024-03-26T20:44:14.987" v="260" actId="1076"/>
      <pc:docMkLst>
        <pc:docMk/>
      </pc:docMkLst>
      <pc:sldChg chg="addSp delSp modSp mod">
        <pc:chgData name="PAPAEFTHYMIOU MARIA" userId="9fc4bb3a-9f47-4932-b338-1082eb2e432c" providerId="ADAL" clId="{FFA22E30-4287-4D00-8F16-F4B4690408A8}" dt="2024-03-26T20:44:14.987" v="260" actId="1076"/>
        <pc:sldMkLst>
          <pc:docMk/>
          <pc:sldMk cId="3198912347" sldId="256"/>
        </pc:sldMkLst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4" creationId="{C50FD42B-8FCF-47A4-2611-17794B854701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5" creationId="{11836DF5-0A58-4FEC-AE55-0D882ABDE149}"/>
          </ac:spMkLst>
        </pc:spChg>
        <pc:spChg chg="del mod">
          <ac:chgData name="PAPAEFTHYMIOU MARIA" userId="9fc4bb3a-9f47-4932-b338-1082eb2e432c" providerId="ADAL" clId="{FFA22E30-4287-4D00-8F16-F4B4690408A8}" dt="2024-03-21T06:35:11.542" v="63" actId="478"/>
          <ac:spMkLst>
            <pc:docMk/>
            <pc:sldMk cId="3198912347" sldId="256"/>
            <ac:spMk id="6" creationId="{2347FEA9-6D79-E0D1-8EF7-7AB188014E9D}"/>
          </ac:spMkLst>
        </pc:spChg>
        <pc:spChg chg="add 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6" creationId="{DE0628BD-9AE1-198B-43E6-D39972FB191E}"/>
          </ac:spMkLst>
        </pc:spChg>
        <pc:spChg chg="del mod">
          <ac:chgData name="PAPAEFTHYMIOU MARIA" userId="9fc4bb3a-9f47-4932-b338-1082eb2e432c" providerId="ADAL" clId="{FFA22E30-4287-4D00-8F16-F4B4690408A8}" dt="2024-03-21T06:35:27.657" v="67" actId="478"/>
          <ac:spMkLst>
            <pc:docMk/>
            <pc:sldMk cId="3198912347" sldId="256"/>
            <ac:spMk id="7" creationId="{1F68CCD3-66B8-6961-616E-9BBBF64CBF32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8" creationId="{E47E0718-7FA6-0BAF-BAC7-CDB115CF4B45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9" creationId="{902269C9-0822-EE12-FF8F-6B1392BF5D58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0" creationId="{A57FC81D-ABD9-E496-36CC-C3FB65A5B617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1" creationId="{D5568C4D-087E-BD19-8825-EACC888C1B88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2" creationId="{79057F56-75DC-2CFC-D3DA-232829F10D26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3" creationId="{B9C0BF76-03F9-BCF9-74EB-4B88919725EF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4" creationId="{C9648B1A-623F-A0B3-E937-95590B32B13D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5" creationId="{289BD586-EBE8-CB68-F630-C75AAB140CC8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6" creationId="{18E3D790-A8F4-AE20-9B8F-7A1CCCE8A8F6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7" creationId="{7E27F574-A0CE-E60B-E8A1-2DFA30987DAC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8" creationId="{2A43F14F-093D-DEDD-8861-9437DAEBD0B4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19" creationId="{CD7F39A6-7DF9-B4EF-E11E-4884AC3749C1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0" creationId="{18148E6E-3A30-F735-6DE8-50E61560E9C6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1" creationId="{D92C0869-BD58-285C-5F94-77A796257D03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2" creationId="{59ADE35B-CECC-B939-7B4F-D4087AD913A2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3" creationId="{E9E3B622-9CDE-CDAD-F7AF-4F44BB9AB9E9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4" creationId="{12D2B7CA-644B-613F-9C4A-AAAD16F95AF7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5" creationId="{2C88C7B2-8CBA-44A1-3402-EF24049873AF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6" creationId="{6EFD8356-7A25-93C1-0716-2F7D04BB216C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7" creationId="{CA709400-8D04-F54F-9E33-A0AF0E8480AB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8" creationId="{CDBDE440-8E62-2ABD-C76C-5D47F8086F27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29" creationId="{A4E4C155-47E1-475C-C165-B20996C9FCC7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0" creationId="{AB6718C2-F7B1-8AE3-684D-791C2844D13E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1" creationId="{4845909F-390D-C8F1-79CF-00EEB3E7DEDE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2" creationId="{5FBF148E-0013-3429-56F0-2B5894617DEB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3" creationId="{113BB2E3-97AF-C2A2-CB3D-1FE84106E390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4" creationId="{4C28E828-1EEC-006F-DD5C-B8FB44D2CE37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5" creationId="{9FC09847-A3AE-C2A5-1336-6AF26C982D7B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36" creationId="{124B2E8E-E900-1C9E-4D01-978A532CF3AF}"/>
          </ac:spMkLst>
        </pc:spChg>
        <pc:spChg chg="del mod">
          <ac:chgData name="PAPAEFTHYMIOU MARIA" userId="9fc4bb3a-9f47-4932-b338-1082eb2e432c" providerId="ADAL" clId="{FFA22E30-4287-4D00-8F16-F4B4690408A8}" dt="2024-03-21T06:39:46.436" v="89" actId="21"/>
          <ac:spMkLst>
            <pc:docMk/>
            <pc:sldMk cId="3198912347" sldId="256"/>
            <ac:spMk id="36" creationId="{F83D5A08-C0AF-5D3B-0FF9-FADA68DB4C58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7" creationId="{798E1F0E-563B-CFD3-3903-0DD50F19C290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8" creationId="{1ABB20F6-5E63-8F37-A820-3243884B075B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39" creationId="{4B0C4D05-C517-2C5A-D095-7332D9325040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0" creationId="{77F94EDD-0806-AFE6-5C9D-93DB5F10D589}"/>
          </ac:spMkLst>
        </pc:spChg>
        <pc:spChg chg="del mod">
          <ac:chgData name="PAPAEFTHYMIOU MARIA" userId="9fc4bb3a-9f47-4932-b338-1082eb2e432c" providerId="ADAL" clId="{FFA22E30-4287-4D00-8F16-F4B4690408A8}" dt="2024-03-21T06:40:00.781" v="94" actId="21"/>
          <ac:spMkLst>
            <pc:docMk/>
            <pc:sldMk cId="3198912347" sldId="256"/>
            <ac:spMk id="40" creationId="{C1F6CA9F-A82B-E743-8C14-98EF661E05C9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41" creationId="{F93FC65B-8188-3161-A231-E582D43B8E41}"/>
          </ac:spMkLst>
        </pc:spChg>
        <pc:spChg chg="mod">
          <ac:chgData name="PAPAEFTHYMIOU MARIA" userId="9fc4bb3a-9f47-4932-b338-1082eb2e432c" providerId="ADAL" clId="{FFA22E30-4287-4D00-8F16-F4B4690408A8}" dt="2024-03-24T11:03:58.404" v="145" actId="1076"/>
          <ac:spMkLst>
            <pc:docMk/>
            <pc:sldMk cId="3198912347" sldId="256"/>
            <ac:spMk id="42" creationId="{1E7FA0A3-63D8-BAFA-A552-B82409EB5816}"/>
          </ac:spMkLst>
        </pc:spChg>
        <pc:spChg chg="del mod">
          <ac:chgData name="PAPAEFTHYMIOU MARIA" userId="9fc4bb3a-9f47-4932-b338-1082eb2e432c" providerId="ADAL" clId="{FFA22E30-4287-4D00-8F16-F4B4690408A8}" dt="2024-03-21T06:37:15.017" v="82" actId="478"/>
          <ac:spMkLst>
            <pc:docMk/>
            <pc:sldMk cId="3198912347" sldId="256"/>
            <ac:spMk id="43" creationId="{683353C2-E157-B40E-E31E-D0C33BBE16DF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3" creationId="{91114A0C-5F40-2440-62EB-6D2E1A027872}"/>
          </ac:spMkLst>
        </pc:spChg>
        <pc:spChg chg="add mod or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4" creationId="{7A619223-F701-A915-F6CA-AA2DFCB42E79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5" creationId="{324AA96A-4184-4878-54BF-74EA1B3661AF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6" creationId="{99E07B43-2A37-6BF6-1326-A47E131B0F6C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7" creationId="{873FD3D6-EB62-C0FC-39B7-36A9ACCD6F58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8" creationId="{48BA0FE1-F9D6-05A9-FE04-75C78AA4D3A2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49" creationId="{22A7ACBC-1777-A6E8-E9AD-143BFD21A650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0" creationId="{548E331B-61F7-FDDD-DAD8-58009C8F0E0E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1" creationId="{FBE68237-1A86-08B1-14B5-3885F0A8FA44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2" creationId="{47B5F3D6-4F10-FA86-D145-5654B6318514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3" creationId="{56BF8AE6-0D2D-5D24-472F-4ED2B4257E10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4" creationId="{39F3FD60-0D24-BDCB-7340-C88D46071C4E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5" creationId="{59AC3009-6D8E-3EC5-6D7A-6700A0D9C58A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6" creationId="{2D6ACF4C-9464-C4FE-C4B0-93DCA8B24430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7" creationId="{C72E8153-B10F-CF9F-8AE0-4254A7480123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8" creationId="{335958E6-AB2A-BDD2-1B91-94812EF70DF0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59" creationId="{E131FD60-D291-A57A-BF80-66C115D1FB06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60" creationId="{AD4A73DF-8F9F-1D2A-F12A-A4474BF87C43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61" creationId="{B0D357C9-25DB-B0AA-D205-5C1312D3C9D7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62" creationId="{F2824BC2-1035-8972-730F-D5AAE9E43051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63" creationId="{2DF14F5B-0CD8-07DD-AA45-CF9D4A2A03A4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192" creationId="{8F02C372-05F4-B9E1-97FF-3F46E1D0F08D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193" creationId="{8E0AB1EF-7560-FD7A-C566-7A4BB0887772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194" creationId="{9C1E2C32-6D64-E121-788F-FA749BFEBE53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195" creationId="{12F6E4C8-CAAB-964F-A240-44B6147DFF60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196" creationId="{6F486936-A0DA-2DDF-1E14-E4EFE1855424}"/>
          </ac:spMkLst>
        </pc:spChg>
        <pc:spChg chg="del mod">
          <ac:chgData name="PAPAEFTHYMIOU MARIA" userId="9fc4bb3a-9f47-4932-b338-1082eb2e432c" providerId="ADAL" clId="{FFA22E30-4287-4D00-8F16-F4B4690408A8}" dt="2024-03-24T11:03:24.551" v="136" actId="478"/>
          <ac:spMkLst>
            <pc:docMk/>
            <pc:sldMk cId="3198912347" sldId="256"/>
            <ac:spMk id="197" creationId="{53B5BE14-1983-3214-EA9B-5BBD2A644CD3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198" creationId="{A30A3EEC-A38F-B5C1-C59E-F1B996DA21A2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199" creationId="{B177C3E8-E75C-0D50-BFD8-103D71EB2798}"/>
          </ac:spMkLst>
        </pc:spChg>
        <pc:spChg chg="del mod">
          <ac:chgData name="PAPAEFTHYMIOU MARIA" userId="9fc4bb3a-9f47-4932-b338-1082eb2e432c" providerId="ADAL" clId="{FFA22E30-4287-4D00-8F16-F4B4690408A8}" dt="2024-03-24T11:00:29.542" v="124" actId="21"/>
          <ac:spMkLst>
            <pc:docMk/>
            <pc:sldMk cId="3198912347" sldId="256"/>
            <ac:spMk id="200" creationId="{DE6E1CF1-E00C-4B94-706F-F5CD4ECD5ACA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01" creationId="{39B293C2-15AB-1688-B4D6-C7A4AB689763}"/>
          </ac:spMkLst>
        </pc:spChg>
        <pc:spChg chg="del mod">
          <ac:chgData name="PAPAEFTHYMIOU MARIA" userId="9fc4bb3a-9f47-4932-b338-1082eb2e432c" providerId="ADAL" clId="{FFA22E30-4287-4D00-8F16-F4B4690408A8}" dt="2024-03-24T11:00:24.945" v="123" actId="21"/>
          <ac:spMkLst>
            <pc:docMk/>
            <pc:sldMk cId="3198912347" sldId="256"/>
            <ac:spMk id="202" creationId="{A43F88D8-7A1F-AB07-B628-16FA223E3E9A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03" creationId="{7826DCAD-04D1-88A7-34D4-9E5DE2CBE754}"/>
          </ac:spMkLst>
        </pc:spChg>
        <pc:spChg chg="del mod">
          <ac:chgData name="PAPAEFTHYMIOU MARIA" userId="9fc4bb3a-9f47-4932-b338-1082eb2e432c" providerId="ADAL" clId="{FFA22E30-4287-4D00-8F16-F4B4690408A8}" dt="2024-03-24T11:00:21.804" v="122" actId="21"/>
          <ac:spMkLst>
            <pc:docMk/>
            <pc:sldMk cId="3198912347" sldId="256"/>
            <ac:spMk id="204" creationId="{87DBC75B-F11A-2809-513E-C76EE510C068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05" creationId="{09385ACC-0F68-CF16-F305-D5C3BEADF3A6}"/>
          </ac:spMkLst>
        </pc:spChg>
        <pc:spChg chg="del mod">
          <ac:chgData name="PAPAEFTHYMIOU MARIA" userId="9fc4bb3a-9f47-4932-b338-1082eb2e432c" providerId="ADAL" clId="{FFA22E30-4287-4D00-8F16-F4B4690408A8}" dt="2024-03-24T11:00:17.826" v="121" actId="21"/>
          <ac:spMkLst>
            <pc:docMk/>
            <pc:sldMk cId="3198912347" sldId="256"/>
            <ac:spMk id="206" creationId="{4BFBB183-DC53-DFA1-E5F7-1DAF962BB0F1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07" creationId="{322640DC-D613-87E7-9E33-DF795E126F08}"/>
          </ac:spMkLst>
        </pc:spChg>
        <pc:spChg chg="del mod">
          <ac:chgData name="PAPAEFTHYMIOU MARIA" userId="9fc4bb3a-9f47-4932-b338-1082eb2e432c" providerId="ADAL" clId="{FFA22E30-4287-4D00-8F16-F4B4690408A8}" dt="2024-03-24T11:00:14.069" v="120" actId="21"/>
          <ac:spMkLst>
            <pc:docMk/>
            <pc:sldMk cId="3198912347" sldId="256"/>
            <ac:spMk id="208" creationId="{77E9E066-4D64-5F7D-169C-4CF2DEFB00B5}"/>
          </ac:spMkLst>
        </pc:spChg>
        <pc:spChg chg="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09" creationId="{C1E374CF-1122-0D63-954C-350E854561D7}"/>
          </ac:spMkLst>
        </pc:spChg>
        <pc:spChg chg="add 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10" creationId="{18E30E13-AD1C-ACDB-7F2D-15499CD90547}"/>
          </ac:spMkLst>
        </pc:spChg>
        <pc:spChg chg="add 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11" creationId="{F293D60A-D7B6-6AAB-9F1E-CB97B9AA346B}"/>
          </ac:spMkLst>
        </pc:spChg>
        <pc:spChg chg="add mod">
          <ac:chgData name="PAPAEFTHYMIOU MARIA" userId="9fc4bb3a-9f47-4932-b338-1082eb2e432c" providerId="ADAL" clId="{FFA22E30-4287-4D00-8F16-F4B4690408A8}" dt="2024-03-26T20:44:14.987" v="260" actId="1076"/>
          <ac:spMkLst>
            <pc:docMk/>
            <pc:sldMk cId="3198912347" sldId="256"/>
            <ac:spMk id="212" creationId="{0C23F09E-0B59-E6D9-8DB1-F2A576C7304C}"/>
          </ac:spMkLst>
        </pc:spChg>
        <pc:spChg chg="add del mod">
          <ac:chgData name="PAPAEFTHYMIOU MARIA" userId="9fc4bb3a-9f47-4932-b338-1082eb2e432c" providerId="ADAL" clId="{FFA22E30-4287-4D00-8F16-F4B4690408A8}" dt="2024-03-24T11:08:02.927" v="177" actId="21"/>
          <ac:spMkLst>
            <pc:docMk/>
            <pc:sldMk cId="3198912347" sldId="256"/>
            <ac:spMk id="213" creationId="{D6117BF9-F13F-5AAE-3EAB-67CC867672F9}"/>
          </ac:spMkLst>
        </pc:spChg>
        <pc:spChg chg="mod">
          <ac:chgData name="PAPAEFTHYMIOU MARIA" userId="9fc4bb3a-9f47-4932-b338-1082eb2e432c" providerId="ADAL" clId="{FFA22E30-4287-4D00-8F16-F4B4690408A8}" dt="2024-03-26T20:43:57.271" v="258" actId="1076"/>
          <ac:spMkLst>
            <pc:docMk/>
            <pc:sldMk cId="3198912347" sldId="256"/>
            <ac:spMk id="224" creationId="{A99DA1B4-CC44-B561-69CC-31B4F13813C2}"/>
          </ac:spMkLst>
        </pc:spChg>
        <pc:grpChg chg="mod">
          <ac:chgData name="PAPAEFTHYMIOU MARIA" userId="9fc4bb3a-9f47-4932-b338-1082eb2e432c" providerId="ADAL" clId="{FFA22E30-4287-4D00-8F16-F4B4690408A8}" dt="2024-03-24T11:00:09.562" v="119" actId="338"/>
          <ac:grpSpMkLst>
            <pc:docMk/>
            <pc:sldMk cId="3198912347" sldId="256"/>
            <ac:grpSpMk id="1" creationId="{00000000-0000-0000-0000-000000000000}"/>
          </ac:grpSpMkLst>
        </pc:grpChg>
        <pc:grpChg chg="del mod">
          <ac:chgData name="PAPAEFTHYMIOU MARIA" userId="9fc4bb3a-9f47-4932-b338-1082eb2e432c" providerId="ADAL" clId="{FFA22E30-4287-4D00-8F16-F4B4690408A8}" dt="2024-03-24T11:04:30.931" v="151" actId="21"/>
          <ac:grpSpMkLst>
            <pc:docMk/>
            <pc:sldMk cId="3198912347" sldId="256"/>
            <ac:grpSpMk id="3" creationId="{273DB1C7-315B-208E-4E86-F642F737F636}"/>
          </ac:grpSpMkLst>
        </pc:grpChg>
        <pc:grpChg chg="mod">
          <ac:chgData name="PAPAEFTHYMIOU MARIA" userId="9fc4bb3a-9f47-4932-b338-1082eb2e432c" providerId="ADAL" clId="{FFA22E30-4287-4D00-8F16-F4B4690408A8}" dt="2024-03-26T20:44:14.987" v="260" actId="1076"/>
          <ac:grpSpMkLst>
            <pc:docMk/>
            <pc:sldMk cId="3198912347" sldId="256"/>
            <ac:grpSpMk id="7" creationId="{6852129A-B025-3706-5DCE-67AA6E51A16B}"/>
          </ac:grpSpMkLst>
        </pc:grpChg>
        <pc:grpChg chg="del">
          <ac:chgData name="PAPAEFTHYMIOU MARIA" userId="9fc4bb3a-9f47-4932-b338-1082eb2e432c" providerId="ADAL" clId="{FFA22E30-4287-4D00-8F16-F4B4690408A8}" dt="2024-03-21T06:33:32.487" v="2" actId="478"/>
          <ac:grpSpMkLst>
            <pc:docMk/>
            <pc:sldMk cId="3198912347" sldId="256"/>
            <ac:grpSpMk id="153" creationId="{B57C1CC2-B55E-096C-37A1-3183326ECC37}"/>
          </ac:grpSpMkLst>
        </pc:grpChg>
        <pc:grpChg chg="add mod">
          <ac:chgData name="PAPAEFTHYMIOU MARIA" userId="9fc4bb3a-9f47-4932-b338-1082eb2e432c" providerId="ADAL" clId="{FFA22E30-4287-4D00-8F16-F4B4690408A8}" dt="2024-03-26T20:44:14.987" v="260" actId="1076"/>
          <ac:grpSpMkLst>
            <pc:docMk/>
            <pc:sldMk cId="3198912347" sldId="256"/>
            <ac:grpSpMk id="214" creationId="{E23A7A1A-12B0-4877-A830-5DCB23476E66}"/>
          </ac:grpSpMkLst>
        </pc:grpChg>
        <pc:grpChg chg="add mod">
          <ac:chgData name="PAPAEFTHYMIOU MARIA" userId="9fc4bb3a-9f47-4932-b338-1082eb2e432c" providerId="ADAL" clId="{FFA22E30-4287-4D00-8F16-F4B4690408A8}" dt="2024-03-26T20:44:14.987" v="260" actId="1076"/>
          <ac:grpSpMkLst>
            <pc:docMk/>
            <pc:sldMk cId="3198912347" sldId="256"/>
            <ac:grpSpMk id="215" creationId="{5D3D4A8E-75C7-2767-2D99-58B940568F67}"/>
          </ac:grpSpMkLst>
        </pc:grpChg>
        <pc:picChg chg="add del mod">
          <ac:chgData name="PAPAEFTHYMIOU MARIA" userId="9fc4bb3a-9f47-4932-b338-1082eb2e432c" providerId="ADAL" clId="{FFA22E30-4287-4D00-8F16-F4B4690408A8}" dt="2024-03-24T11:00:09.562" v="119" actId="338"/>
          <ac:picMkLst>
            <pc:docMk/>
            <pc:sldMk cId="3198912347" sldId="256"/>
            <ac:picMk id="2" creationId="{E4574ED5-E057-9024-B3CC-CB8FDD864F67}"/>
          </ac:picMkLst>
        </pc:picChg>
        <pc:picChg chg="add del mod">
          <ac:chgData name="PAPAEFTHYMIOU MARIA" userId="9fc4bb3a-9f47-4932-b338-1082eb2e432c" providerId="ADAL" clId="{FFA22E30-4287-4D00-8F16-F4B4690408A8}" dt="2024-03-21T06:35:03.997" v="61" actId="338"/>
          <ac:picMkLst>
            <pc:docMk/>
            <pc:sldMk cId="3198912347" sldId="256"/>
            <ac:picMk id="2" creationId="{EA7B4F4D-DE04-678C-5860-1278678A17F2}"/>
          </ac:picMkLst>
        </pc:picChg>
      </pc:sldChg>
      <pc:sldChg chg="addSp delSp modSp mod">
        <pc:chgData name="PAPAEFTHYMIOU MARIA" userId="9fc4bb3a-9f47-4932-b338-1082eb2e432c" providerId="ADAL" clId="{FFA22E30-4287-4D00-8F16-F4B4690408A8}" dt="2024-03-24T11:07:23.517" v="172" actId="255"/>
        <pc:sldMkLst>
          <pc:docMk/>
          <pc:sldMk cId="2407624871" sldId="257"/>
        </pc:sldMkLst>
        <pc:spChg chg="add mod">
          <ac:chgData name="PAPAEFTHYMIOU MARIA" userId="9fc4bb3a-9f47-4932-b338-1082eb2e432c" providerId="ADAL" clId="{FFA22E30-4287-4D00-8F16-F4B4690408A8}" dt="2024-03-24T11:04:40.089" v="152" actId="313"/>
          <ac:spMkLst>
            <pc:docMk/>
            <pc:sldMk cId="2407624871" sldId="257"/>
            <ac:spMk id="3" creationId="{88605ACF-E570-9EA9-037D-4297B3F63979}"/>
          </ac:spMkLst>
        </pc:spChg>
        <pc:spChg chg="add mod">
          <ac:chgData name="PAPAEFTHYMIOU MARIA" userId="9fc4bb3a-9f47-4932-b338-1082eb2e432c" providerId="ADAL" clId="{FFA22E30-4287-4D00-8F16-F4B4690408A8}" dt="2024-03-24T11:07:23.517" v="172" actId="255"/>
          <ac:spMkLst>
            <pc:docMk/>
            <pc:sldMk cId="2407624871" sldId="257"/>
            <ac:spMk id="4" creationId="{D0DD28F8-1145-A5B8-14EE-A3629644E05A}"/>
          </ac:spMkLst>
        </pc:spChg>
        <pc:picChg chg="add mod">
          <ac:chgData name="PAPAEFTHYMIOU MARIA" userId="9fc4bb3a-9f47-4932-b338-1082eb2e432c" providerId="ADAL" clId="{FFA22E30-4287-4D00-8F16-F4B4690408A8}" dt="2024-03-21T06:33:22.717" v="1"/>
          <ac:picMkLst>
            <pc:docMk/>
            <pc:sldMk cId="2407624871" sldId="257"/>
            <ac:picMk id="2" creationId="{6D34E0BE-9D3B-F4D4-7D17-39FEF81D3B0F}"/>
          </ac:picMkLst>
        </pc:picChg>
        <pc:picChg chg="del">
          <ac:chgData name="PAPAEFTHYMIOU MARIA" userId="9fc4bb3a-9f47-4932-b338-1082eb2e432c" providerId="ADAL" clId="{FFA22E30-4287-4D00-8F16-F4B4690408A8}" dt="2024-03-21T06:33:19.817" v="0" actId="478"/>
          <ac:picMkLst>
            <pc:docMk/>
            <pc:sldMk cId="2407624871" sldId="257"/>
            <ac:picMk id="4" creationId="{BB4851FE-4A56-2B36-DA97-07871FA87495}"/>
          </ac:picMkLst>
        </pc:picChg>
      </pc:sldChg>
    </pc:docChg>
  </pc:docChgLst>
  <pc:docChgLst>
    <pc:chgData name="PAPAEFTHYMIOU MARIA" userId="9fc4bb3a-9f47-4932-b338-1082eb2e432c" providerId="ADAL" clId="{C3DA4F39-8978-40A1-BD46-C97818A2D675}"/>
    <pc:docChg chg="delSld modSld">
      <pc:chgData name="PAPAEFTHYMIOU MARIA" userId="9fc4bb3a-9f47-4932-b338-1082eb2e432c" providerId="ADAL" clId="{C3DA4F39-8978-40A1-BD46-C97818A2D675}" dt="2024-04-23T09:10:26.963" v="56" actId="1076"/>
      <pc:docMkLst>
        <pc:docMk/>
      </pc:docMkLst>
      <pc:sldChg chg="modSp mod">
        <pc:chgData name="PAPAEFTHYMIOU MARIA" userId="9fc4bb3a-9f47-4932-b338-1082eb2e432c" providerId="ADAL" clId="{C3DA4F39-8978-40A1-BD46-C97818A2D675}" dt="2024-04-23T09:10:26.963" v="56" actId="1076"/>
        <pc:sldMkLst>
          <pc:docMk/>
          <pc:sldMk cId="3198912347" sldId="256"/>
        </pc:sldMkLst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6" creationId="{DE0628BD-9AE1-198B-43E6-D39972FB191E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36" creationId="{124B2E8E-E900-1C9E-4D01-978A532CF3AF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0" creationId="{77F94EDD-0806-AFE6-5C9D-93DB5F10D589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3" creationId="{91114A0C-5F40-2440-62EB-6D2E1A027872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4" creationId="{7A619223-F701-A915-F6CA-AA2DFCB42E79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5" creationId="{324AA96A-4184-4878-54BF-74EA1B3661AF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6" creationId="{99E07B43-2A37-6BF6-1326-A47E131B0F6C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7" creationId="{873FD3D6-EB62-C0FC-39B7-36A9ACCD6F58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8" creationId="{48BA0FE1-F9D6-05A9-FE04-75C78AA4D3A2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49" creationId="{22A7ACBC-1777-A6E8-E9AD-143BFD21A650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0" creationId="{548E331B-61F7-FDDD-DAD8-58009C8F0E0E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1" creationId="{FBE68237-1A86-08B1-14B5-3885F0A8FA44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2" creationId="{47B5F3D6-4F10-FA86-D145-5654B6318514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3" creationId="{56BF8AE6-0D2D-5D24-472F-4ED2B4257E10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4" creationId="{39F3FD60-0D24-BDCB-7340-C88D46071C4E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5" creationId="{59AC3009-6D8E-3EC5-6D7A-6700A0D9C58A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6" creationId="{2D6ACF4C-9464-C4FE-C4B0-93DCA8B24430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7" creationId="{C72E8153-B10F-CF9F-8AE0-4254A7480123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8" creationId="{335958E6-AB2A-BDD2-1B91-94812EF70DF0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59" creationId="{E131FD60-D291-A57A-BF80-66C115D1FB06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60" creationId="{AD4A73DF-8F9F-1D2A-F12A-A4474BF87C43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61" creationId="{B0D357C9-25DB-B0AA-D205-5C1312D3C9D7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62" creationId="{F2824BC2-1035-8972-730F-D5AAE9E43051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63" creationId="{2DF14F5B-0CD8-07DD-AA45-CF9D4A2A03A4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192" creationId="{8F02C372-05F4-B9E1-97FF-3F46E1D0F08D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193" creationId="{8E0AB1EF-7560-FD7A-C566-7A4BB0887772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194" creationId="{9C1E2C32-6D64-E121-788F-FA749BFEBE53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195" creationId="{12F6E4C8-CAAB-964F-A240-44B6147DFF60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196" creationId="{6F486936-A0DA-2DDF-1E14-E4EFE1855424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198" creationId="{A30A3EEC-A38F-B5C1-C59E-F1B996DA21A2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199" creationId="{B177C3E8-E75C-0D50-BFD8-103D71EB2798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01" creationId="{39B293C2-15AB-1688-B4D6-C7A4AB689763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03" creationId="{7826DCAD-04D1-88A7-34D4-9E5DE2CBE754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05" creationId="{09385ACC-0F68-CF16-F305-D5C3BEADF3A6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07" creationId="{322640DC-D613-87E7-9E33-DF795E126F08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09" creationId="{C1E374CF-1122-0D63-954C-350E854561D7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10" creationId="{18E30E13-AD1C-ACDB-7F2D-15499CD90547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11" creationId="{F293D60A-D7B6-6AAB-9F1E-CB97B9AA346B}"/>
          </ac:spMkLst>
        </pc:spChg>
        <pc:spChg chg="mod">
          <ac:chgData name="PAPAEFTHYMIOU MARIA" userId="9fc4bb3a-9f47-4932-b338-1082eb2e432c" providerId="ADAL" clId="{C3DA4F39-8978-40A1-BD46-C97818A2D675}" dt="2024-04-23T09:08:58.092" v="45" actId="1076"/>
          <ac:spMkLst>
            <pc:docMk/>
            <pc:sldMk cId="3198912347" sldId="256"/>
            <ac:spMk id="212" creationId="{0C23F09E-0B59-E6D9-8DB1-F2A576C7304C}"/>
          </ac:spMkLst>
        </pc:spChg>
        <pc:spChg chg="mod">
          <ac:chgData name="PAPAEFTHYMIOU MARIA" userId="9fc4bb3a-9f47-4932-b338-1082eb2e432c" providerId="ADAL" clId="{C3DA4F39-8978-40A1-BD46-C97818A2D675}" dt="2024-04-23T09:10:26.963" v="56" actId="1076"/>
          <ac:spMkLst>
            <pc:docMk/>
            <pc:sldMk cId="3198912347" sldId="256"/>
            <ac:spMk id="224" creationId="{A99DA1B4-CC44-B561-69CC-31B4F13813C2}"/>
          </ac:spMkLst>
        </pc:spChg>
        <pc:grpChg chg="mod">
          <ac:chgData name="PAPAEFTHYMIOU MARIA" userId="9fc4bb3a-9f47-4932-b338-1082eb2e432c" providerId="ADAL" clId="{C3DA4F39-8978-40A1-BD46-C97818A2D675}" dt="2024-04-23T09:08:58.092" v="45" actId="1076"/>
          <ac:grpSpMkLst>
            <pc:docMk/>
            <pc:sldMk cId="3198912347" sldId="256"/>
            <ac:grpSpMk id="7" creationId="{6852129A-B025-3706-5DCE-67AA6E51A16B}"/>
          </ac:grpSpMkLst>
        </pc:grpChg>
        <pc:grpChg chg="mod">
          <ac:chgData name="PAPAEFTHYMIOU MARIA" userId="9fc4bb3a-9f47-4932-b338-1082eb2e432c" providerId="ADAL" clId="{C3DA4F39-8978-40A1-BD46-C97818A2D675}" dt="2024-04-23T09:08:58.092" v="45" actId="1076"/>
          <ac:grpSpMkLst>
            <pc:docMk/>
            <pc:sldMk cId="3198912347" sldId="256"/>
            <ac:grpSpMk id="214" creationId="{E23A7A1A-12B0-4877-A830-5DCB23476E66}"/>
          </ac:grpSpMkLst>
        </pc:grpChg>
        <pc:grpChg chg="mod">
          <ac:chgData name="PAPAEFTHYMIOU MARIA" userId="9fc4bb3a-9f47-4932-b338-1082eb2e432c" providerId="ADAL" clId="{C3DA4F39-8978-40A1-BD46-C97818A2D675}" dt="2024-04-23T09:08:58.092" v="45" actId="1076"/>
          <ac:grpSpMkLst>
            <pc:docMk/>
            <pc:sldMk cId="3198912347" sldId="256"/>
            <ac:grpSpMk id="215" creationId="{5D3D4A8E-75C7-2767-2D99-58B940568F67}"/>
          </ac:grpSpMkLst>
        </pc:grpChg>
      </pc:sldChg>
      <pc:sldChg chg="del">
        <pc:chgData name="PAPAEFTHYMIOU MARIA" userId="9fc4bb3a-9f47-4932-b338-1082eb2e432c" providerId="ADAL" clId="{C3DA4F39-8978-40A1-BD46-C97818A2D675}" dt="2024-04-23T09:06:36.390" v="0" actId="2696"/>
        <pc:sldMkLst>
          <pc:docMk/>
          <pc:sldMk cId="2407624871" sldId="257"/>
        </pc:sldMkLst>
      </pc:sldChg>
    </pc:docChg>
  </pc:docChgLst>
  <pc:docChgLst>
    <pc:chgData name="mpapaefthymiou@o365.uth.gr" userId="9fc4bb3a-9f47-4932-b338-1082eb2e432c" providerId="ADAL" clId="{7B4D314F-A36F-4677-B8A1-CDCBFF5E915D}"/>
    <pc:docChg chg="modSld">
      <pc:chgData name="mpapaefthymiou@o365.uth.gr" userId="9fc4bb3a-9f47-4932-b338-1082eb2e432c" providerId="ADAL" clId="{7B4D314F-A36F-4677-B8A1-CDCBFF5E915D}" dt="2024-05-22T09:43:06.027" v="0" actId="255"/>
      <pc:docMkLst>
        <pc:docMk/>
      </pc:docMkLst>
      <pc:sldChg chg="modSp mod">
        <pc:chgData name="mpapaefthymiou@o365.uth.gr" userId="9fc4bb3a-9f47-4932-b338-1082eb2e432c" providerId="ADAL" clId="{7B4D314F-A36F-4677-B8A1-CDCBFF5E915D}" dt="2024-05-22T09:43:06.027" v="0" actId="255"/>
        <pc:sldMkLst>
          <pc:docMk/>
          <pc:sldMk cId="3198912347" sldId="256"/>
        </pc:sldMkLst>
        <pc:spChg chg="mod">
          <ac:chgData name="mpapaefthymiou@o365.uth.gr" userId="9fc4bb3a-9f47-4932-b338-1082eb2e432c" providerId="ADAL" clId="{7B4D314F-A36F-4677-B8A1-CDCBFF5E915D}" dt="2024-05-22T09:43:06.027" v="0" actId="255"/>
          <ac:spMkLst>
            <pc:docMk/>
            <pc:sldMk cId="3198912347" sldId="256"/>
            <ac:spMk id="224" creationId="{A99DA1B4-CC44-B561-69CC-31B4F13813C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95217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41731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1572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4371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79679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70637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99981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98649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61967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92396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91988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B21DF2-0662-4C4C-80D3-6B85C8B89236}" type="datetimeFigureOut">
              <a:rPr lang="el-GR" smtClean="0"/>
              <a:t>4/6/2024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FE0D05-0973-4921-BAE1-EAA1B114F69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73125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TextBox 223">
            <a:extLst>
              <a:ext uri="{FF2B5EF4-FFF2-40B4-BE49-F238E27FC236}">
                <a16:creationId xmlns:a16="http://schemas.microsoft.com/office/drawing/2014/main" id="{A99DA1B4-CC44-B561-69CC-31B4F13813C2}"/>
              </a:ext>
            </a:extLst>
          </p:cNvPr>
          <p:cNvSpPr txBox="1"/>
          <p:nvPr/>
        </p:nvSpPr>
        <p:spPr>
          <a:xfrm>
            <a:off x="148281" y="562605"/>
            <a:ext cx="9144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Supplementary </a:t>
            </a:r>
            <a:r>
              <a:rPr lang="en-US" sz="12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Figure</a:t>
            </a:r>
            <a:r>
              <a:rPr kumimoji="0" lang="en-US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 S3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: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-regression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 of concentration (as effect size) for SOD-CAT-POX assays </a:t>
            </a:r>
            <a:endParaRPr kumimoji="0" lang="el-G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grpSp>
        <p:nvGrpSpPr>
          <p:cNvPr id="215" name="Ομάδα 214">
            <a:extLst>
              <a:ext uri="{FF2B5EF4-FFF2-40B4-BE49-F238E27FC236}">
                <a16:creationId xmlns:a16="http://schemas.microsoft.com/office/drawing/2014/main" id="{5D3D4A8E-75C7-2767-2D99-58B940568F67}"/>
              </a:ext>
            </a:extLst>
          </p:cNvPr>
          <p:cNvGrpSpPr/>
          <p:nvPr/>
        </p:nvGrpSpPr>
        <p:grpSpPr>
          <a:xfrm>
            <a:off x="1183664" y="1435100"/>
            <a:ext cx="5737835" cy="4126812"/>
            <a:chOff x="1509667" y="2218780"/>
            <a:chExt cx="5143500" cy="3778250"/>
          </a:xfrm>
        </p:grpSpPr>
        <p:grpSp>
          <p:nvGrpSpPr>
            <p:cNvPr id="214" name="Ομάδα 213">
              <a:extLst>
                <a:ext uri="{FF2B5EF4-FFF2-40B4-BE49-F238E27FC236}">
                  <a16:creationId xmlns:a16="http://schemas.microsoft.com/office/drawing/2014/main" id="{E23A7A1A-12B0-4877-A830-5DCB23476E66}"/>
                </a:ext>
              </a:extLst>
            </p:cNvPr>
            <p:cNvGrpSpPr/>
            <p:nvPr/>
          </p:nvGrpSpPr>
          <p:grpSpPr>
            <a:xfrm>
              <a:off x="1509667" y="2218780"/>
              <a:ext cx="5143500" cy="3778250"/>
              <a:chOff x="5341439" y="1435009"/>
              <a:chExt cx="5143500" cy="3778250"/>
            </a:xfrm>
          </p:grpSpPr>
          <p:grpSp>
            <p:nvGrpSpPr>
              <p:cNvPr id="7" name="Group 4">
                <a:extLst>
                  <a:ext uri="{FF2B5EF4-FFF2-40B4-BE49-F238E27FC236}">
                    <a16:creationId xmlns:a16="http://schemas.microsoft.com/office/drawing/2014/main" id="{6852129A-B025-3706-5DCE-67AA6E51A16B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5341439" y="1435009"/>
                <a:ext cx="5143500" cy="3778250"/>
                <a:chOff x="3244" y="882"/>
                <a:chExt cx="3240" cy="2380"/>
              </a:xfrm>
            </p:grpSpPr>
            <p:sp>
              <p:nvSpPr>
                <p:cNvPr id="36" name="AutoShape 3">
                  <a:extLst>
                    <a:ext uri="{FF2B5EF4-FFF2-40B4-BE49-F238E27FC236}">
                      <a16:creationId xmlns:a16="http://schemas.microsoft.com/office/drawing/2014/main" id="{124B2E8E-E900-1C9E-4D01-978A532CF3AF}"/>
                    </a:ext>
                  </a:extLst>
                </p:cNvPr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3244" y="882"/>
                  <a:ext cx="3240" cy="238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0" name="Rectangle 5">
                  <a:extLst>
                    <a:ext uri="{FF2B5EF4-FFF2-40B4-BE49-F238E27FC236}">
                      <a16:creationId xmlns:a16="http://schemas.microsoft.com/office/drawing/2014/main" id="{77F94EDD-0806-AFE6-5C9D-93DB5F10D58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0" y="917"/>
                  <a:ext cx="3169" cy="2309"/>
                </a:xfrm>
                <a:prstGeom prst="rect">
                  <a:avLst/>
                </a:prstGeom>
                <a:solidFill>
                  <a:srgbClr val="EAF2F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3" name="Rectangle 6">
                  <a:extLst>
                    <a:ext uri="{FF2B5EF4-FFF2-40B4-BE49-F238E27FC236}">
                      <a16:creationId xmlns:a16="http://schemas.microsoft.com/office/drawing/2014/main" id="{91114A0C-5F40-2440-62EB-6D2E1A0278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82" y="921"/>
                  <a:ext cx="3164" cy="2303"/>
                </a:xfrm>
                <a:prstGeom prst="rect">
                  <a:avLst/>
                </a:prstGeom>
                <a:solidFill>
                  <a:srgbClr val="EAF2F3"/>
                </a:solidFill>
                <a:ln w="6350">
                  <a:solidFill>
                    <a:srgbClr val="EAF2F3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dirty="0"/>
                </a:p>
              </p:txBody>
            </p:sp>
            <p:sp>
              <p:nvSpPr>
                <p:cNvPr id="45" name="Rectangle 7">
                  <a:extLst>
                    <a:ext uri="{FF2B5EF4-FFF2-40B4-BE49-F238E27FC236}">
                      <a16:creationId xmlns:a16="http://schemas.microsoft.com/office/drawing/2014/main" id="{324AA96A-4184-4878-54BF-74EA1B3661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5" y="1001"/>
                  <a:ext cx="2770" cy="1909"/>
                </a:xfrm>
                <a:prstGeom prst="rect">
                  <a:avLst/>
                </a:prstGeom>
                <a:solidFill>
                  <a:srgbClr val="FFFFFF"/>
                </a:solidFill>
                <a:ln w="6350">
                  <a:solidFill>
                    <a:srgbClr val="FFFF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6" name="Line 8">
                  <a:extLst>
                    <a:ext uri="{FF2B5EF4-FFF2-40B4-BE49-F238E27FC236}">
                      <a16:creationId xmlns:a16="http://schemas.microsoft.com/office/drawing/2014/main" id="{99E07B43-2A37-6BF6-1326-A47E131B0F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95" y="2862"/>
                  <a:ext cx="2772" cy="0"/>
                </a:xfrm>
                <a:prstGeom prst="line">
                  <a:avLst/>
                </a:prstGeom>
                <a:noFill/>
                <a:ln w="12700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7" name="Line 9">
                  <a:extLst>
                    <a:ext uri="{FF2B5EF4-FFF2-40B4-BE49-F238E27FC236}">
                      <a16:creationId xmlns:a16="http://schemas.microsoft.com/office/drawing/2014/main" id="{873FD3D6-EB62-C0FC-39B7-36A9ACCD6F5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95" y="2259"/>
                  <a:ext cx="2772" cy="0"/>
                </a:xfrm>
                <a:prstGeom prst="line">
                  <a:avLst/>
                </a:prstGeom>
                <a:noFill/>
                <a:ln w="12700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8" name="Line 10">
                  <a:extLst>
                    <a:ext uri="{FF2B5EF4-FFF2-40B4-BE49-F238E27FC236}">
                      <a16:creationId xmlns:a16="http://schemas.microsoft.com/office/drawing/2014/main" id="{48BA0FE1-F9D6-05A9-FE04-75C78AA4D3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95" y="1655"/>
                  <a:ext cx="2772" cy="0"/>
                </a:xfrm>
                <a:prstGeom prst="line">
                  <a:avLst/>
                </a:prstGeom>
                <a:noFill/>
                <a:ln w="12700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9" name="Line 11">
                  <a:extLst>
                    <a:ext uri="{FF2B5EF4-FFF2-40B4-BE49-F238E27FC236}">
                      <a16:creationId xmlns:a16="http://schemas.microsoft.com/office/drawing/2014/main" id="{22A7ACBC-1777-A6E8-E9AD-143BFD21A65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95" y="1051"/>
                  <a:ext cx="2772" cy="0"/>
                </a:xfrm>
                <a:prstGeom prst="line">
                  <a:avLst/>
                </a:prstGeom>
                <a:noFill/>
                <a:ln w="12700" cap="flat">
                  <a:solidFill>
                    <a:srgbClr val="EAF2F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0" name="Oval 12">
                  <a:extLst>
                    <a:ext uri="{FF2B5EF4-FFF2-40B4-BE49-F238E27FC236}">
                      <a16:creationId xmlns:a16="http://schemas.microsoft.com/office/drawing/2014/main" id="{548E331B-61F7-FDDD-DAD8-58009C8F0E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18" y="2733"/>
                  <a:ext cx="123" cy="123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1" name="Oval 13">
                  <a:extLst>
                    <a:ext uri="{FF2B5EF4-FFF2-40B4-BE49-F238E27FC236}">
                      <a16:creationId xmlns:a16="http://schemas.microsoft.com/office/drawing/2014/main" id="{FBE68237-1A86-08B1-14B5-3885F0A8FA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56" y="2657"/>
                  <a:ext cx="248" cy="248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2" name="Oval 14">
                  <a:extLst>
                    <a:ext uri="{FF2B5EF4-FFF2-40B4-BE49-F238E27FC236}">
                      <a16:creationId xmlns:a16="http://schemas.microsoft.com/office/drawing/2014/main" id="{47B5F3D6-4F10-FA86-D145-5654B63185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54" y="2737"/>
                  <a:ext cx="122" cy="123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3" name="Oval 15">
                  <a:extLst>
                    <a:ext uri="{FF2B5EF4-FFF2-40B4-BE49-F238E27FC236}">
                      <a16:creationId xmlns:a16="http://schemas.microsoft.com/office/drawing/2014/main" id="{56BF8AE6-0D2D-5D24-472F-4ED2B4257E1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54" y="2680"/>
                  <a:ext cx="122" cy="123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4" name="Oval 16">
                  <a:extLst>
                    <a:ext uri="{FF2B5EF4-FFF2-40B4-BE49-F238E27FC236}">
                      <a16:creationId xmlns:a16="http://schemas.microsoft.com/office/drawing/2014/main" id="{39F3FD60-0D24-BDCB-7340-C88D46071C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20" y="2499"/>
                  <a:ext cx="248" cy="248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5" name="Oval 17">
                  <a:extLst>
                    <a:ext uri="{FF2B5EF4-FFF2-40B4-BE49-F238E27FC236}">
                      <a16:creationId xmlns:a16="http://schemas.microsoft.com/office/drawing/2014/main" id="{59AC3009-6D8E-3EC5-6D7A-6700A0D9C5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84" y="2485"/>
                  <a:ext cx="123" cy="123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6" name="Oval 18">
                  <a:extLst>
                    <a:ext uri="{FF2B5EF4-FFF2-40B4-BE49-F238E27FC236}">
                      <a16:creationId xmlns:a16="http://schemas.microsoft.com/office/drawing/2014/main" id="{2D6ACF4C-9464-C4FE-C4B0-93DCA8B244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4" y="2491"/>
                  <a:ext cx="60" cy="60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7" name="Oval 19">
                  <a:extLst>
                    <a:ext uri="{FF2B5EF4-FFF2-40B4-BE49-F238E27FC236}">
                      <a16:creationId xmlns:a16="http://schemas.microsoft.com/office/drawing/2014/main" id="{C72E8153-B10F-CF9F-8AE0-4254A74801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79" y="1201"/>
                  <a:ext cx="2" cy="2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8" name="Oval 20">
                  <a:extLst>
                    <a:ext uri="{FF2B5EF4-FFF2-40B4-BE49-F238E27FC236}">
                      <a16:creationId xmlns:a16="http://schemas.microsoft.com/office/drawing/2014/main" id="{335958E6-AB2A-BDD2-1B91-94812EF70D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94" y="1995"/>
                  <a:ext cx="40" cy="41"/>
                </a:xfrm>
                <a:prstGeom prst="ellipse">
                  <a:avLst/>
                </a:prstGeom>
                <a:noFill/>
                <a:ln w="12700">
                  <a:solidFill>
                    <a:srgbClr val="1A476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59" name="Freeform 21">
                  <a:extLst>
                    <a:ext uri="{FF2B5EF4-FFF2-40B4-BE49-F238E27FC236}">
                      <a16:creationId xmlns:a16="http://schemas.microsoft.com/office/drawing/2014/main" id="{E131FD60-D291-A57A-BF80-66C115D1FB0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45" y="2499"/>
                  <a:ext cx="2672" cy="44"/>
                </a:xfrm>
                <a:custGeom>
                  <a:avLst/>
                  <a:gdLst>
                    <a:gd name="T0" fmla="*/ 0 w 1392"/>
                    <a:gd name="T1" fmla="*/ 23 h 23"/>
                    <a:gd name="T2" fmla="*/ 0 w 1392"/>
                    <a:gd name="T3" fmla="*/ 23 h 23"/>
                    <a:gd name="T4" fmla="*/ 0 w 1392"/>
                    <a:gd name="T5" fmla="*/ 23 h 23"/>
                    <a:gd name="T6" fmla="*/ 696 w 1392"/>
                    <a:gd name="T7" fmla="*/ 11 h 23"/>
                    <a:gd name="T8" fmla="*/ 696 w 1392"/>
                    <a:gd name="T9" fmla="*/ 11 h 23"/>
                    <a:gd name="T10" fmla="*/ 696 w 1392"/>
                    <a:gd name="T11" fmla="*/ 11 h 23"/>
                    <a:gd name="T12" fmla="*/ 1392 w 1392"/>
                    <a:gd name="T13" fmla="*/ 0 h 23"/>
                    <a:gd name="T14" fmla="*/ 1392 w 1392"/>
                    <a:gd name="T15" fmla="*/ 0 h 23"/>
                    <a:gd name="T16" fmla="*/ 1392 w 1392"/>
                    <a:gd name="T17" fmla="*/ 0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</a:cxnLst>
                  <a:rect l="0" t="0" r="r" b="b"/>
                  <a:pathLst>
                    <a:path w="1392" h="23">
                      <a:moveTo>
                        <a:pt x="0" y="23"/>
                      </a:moveTo>
                      <a:lnTo>
                        <a:pt x="0" y="23"/>
                      </a:lnTo>
                      <a:lnTo>
                        <a:pt x="0" y="23"/>
                      </a:lnTo>
                      <a:lnTo>
                        <a:pt x="696" y="11"/>
                      </a:lnTo>
                      <a:lnTo>
                        <a:pt x="696" y="11"/>
                      </a:lnTo>
                      <a:lnTo>
                        <a:pt x="696" y="11"/>
                      </a:lnTo>
                      <a:lnTo>
                        <a:pt x="1392" y="0"/>
                      </a:lnTo>
                      <a:lnTo>
                        <a:pt x="1392" y="0"/>
                      </a:lnTo>
                      <a:lnTo>
                        <a:pt x="1392" y="0"/>
                      </a:lnTo>
                    </a:path>
                  </a:pathLst>
                </a:custGeom>
                <a:noFill/>
                <a:ln w="12700">
                  <a:solidFill>
                    <a:srgbClr val="90353B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0" name="Line 22">
                  <a:extLst>
                    <a:ext uri="{FF2B5EF4-FFF2-40B4-BE49-F238E27FC236}">
                      <a16:creationId xmlns:a16="http://schemas.microsoft.com/office/drawing/2014/main" id="{AD4A73DF-8F9F-1D2A-F12A-A4474BF87C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595" y="1001"/>
                  <a:ext cx="0" cy="1911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1" name="Line 23">
                  <a:extLst>
                    <a:ext uri="{FF2B5EF4-FFF2-40B4-BE49-F238E27FC236}">
                      <a16:creationId xmlns:a16="http://schemas.microsoft.com/office/drawing/2014/main" id="{B0D357C9-25DB-B0AA-D205-5C1312D3C9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563" y="2862"/>
                  <a:ext cx="32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62" name="Rectangle 24">
                  <a:extLst>
                    <a:ext uri="{FF2B5EF4-FFF2-40B4-BE49-F238E27FC236}">
                      <a16:creationId xmlns:a16="http://schemas.microsoft.com/office/drawing/2014/main" id="{F2824BC2-1035-8972-730F-D5AAE9E430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466" y="2787"/>
                  <a:ext cx="81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l-GR" altLang="el-G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3" name="Line 25">
                  <a:extLst>
                    <a:ext uri="{FF2B5EF4-FFF2-40B4-BE49-F238E27FC236}">
                      <a16:creationId xmlns:a16="http://schemas.microsoft.com/office/drawing/2014/main" id="{2DF14F5B-0CD8-07DD-AA45-CF9D4A2A03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563" y="2259"/>
                  <a:ext cx="32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2" name="Rectangle 26">
                  <a:extLst>
                    <a:ext uri="{FF2B5EF4-FFF2-40B4-BE49-F238E27FC236}">
                      <a16:creationId xmlns:a16="http://schemas.microsoft.com/office/drawing/2014/main" id="{8F02C372-05F4-B9E1-97FF-3F46E1D0F0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446" y="2188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</a:rPr>
                    <a:t>200</a:t>
                  </a:r>
                  <a:endParaRPr kumimoji="0" lang="el-GR" altLang="el-G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193" name="Line 27">
                  <a:extLst>
                    <a:ext uri="{FF2B5EF4-FFF2-40B4-BE49-F238E27FC236}">
                      <a16:creationId xmlns:a16="http://schemas.microsoft.com/office/drawing/2014/main" id="{8E0AB1EF-7560-FD7A-C566-7A4BB08877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563" y="1655"/>
                  <a:ext cx="32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4" name="Rectangle 28">
                  <a:extLst>
                    <a:ext uri="{FF2B5EF4-FFF2-40B4-BE49-F238E27FC236}">
                      <a16:creationId xmlns:a16="http://schemas.microsoft.com/office/drawing/2014/main" id="{9C1E2C32-6D64-E121-788F-FA749BFEBE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446" y="1584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</a:rPr>
                    <a:t>400</a:t>
                  </a:r>
                  <a:endParaRPr kumimoji="0" lang="el-GR" altLang="el-G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195" name="Line 29">
                  <a:extLst>
                    <a:ext uri="{FF2B5EF4-FFF2-40B4-BE49-F238E27FC236}">
                      <a16:creationId xmlns:a16="http://schemas.microsoft.com/office/drawing/2014/main" id="{12F6E4C8-CAAB-964F-A240-44B6147DFF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563" y="1051"/>
                  <a:ext cx="32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6" name="Rectangle 30">
                  <a:extLst>
                    <a:ext uri="{FF2B5EF4-FFF2-40B4-BE49-F238E27FC236}">
                      <a16:creationId xmlns:a16="http://schemas.microsoft.com/office/drawing/2014/main" id="{6F486936-A0DA-2DDF-1E14-E4EFE18554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446" y="982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altLang="el-G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</a:rPr>
                    <a:t>600</a:t>
                  </a:r>
                  <a:endParaRPr kumimoji="0" lang="el-GR" altLang="el-G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198" name="Line 32">
                  <a:extLst>
                    <a:ext uri="{FF2B5EF4-FFF2-40B4-BE49-F238E27FC236}">
                      <a16:creationId xmlns:a16="http://schemas.microsoft.com/office/drawing/2014/main" id="{A30A3EEC-A38F-B5C1-C59E-F1B996DA21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95" y="2912"/>
                  <a:ext cx="2772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199" name="Line 33">
                  <a:extLst>
                    <a:ext uri="{FF2B5EF4-FFF2-40B4-BE49-F238E27FC236}">
                      <a16:creationId xmlns:a16="http://schemas.microsoft.com/office/drawing/2014/main" id="{B177C3E8-E75C-0D50-BFD8-103D71EB279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45" y="2912"/>
                  <a:ext cx="0" cy="33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1" name="Line 35">
                  <a:extLst>
                    <a:ext uri="{FF2B5EF4-FFF2-40B4-BE49-F238E27FC236}">
                      <a16:creationId xmlns:a16="http://schemas.microsoft.com/office/drawing/2014/main" id="{39B293C2-15AB-1688-B4D6-C7A4AB6897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13" y="2912"/>
                  <a:ext cx="0" cy="33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3" name="Line 37">
                  <a:extLst>
                    <a:ext uri="{FF2B5EF4-FFF2-40B4-BE49-F238E27FC236}">
                      <a16:creationId xmlns:a16="http://schemas.microsoft.com/office/drawing/2014/main" id="{7826DCAD-04D1-88A7-34D4-9E5DE2CBE7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81" y="2912"/>
                  <a:ext cx="0" cy="33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5" name="Line 39">
                  <a:extLst>
                    <a:ext uri="{FF2B5EF4-FFF2-40B4-BE49-F238E27FC236}">
                      <a16:creationId xmlns:a16="http://schemas.microsoft.com/office/drawing/2014/main" id="{09385ACC-0F68-CF16-F305-D5C3BEADF3A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49" y="2912"/>
                  <a:ext cx="0" cy="33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7" name="Line 41">
                  <a:extLst>
                    <a:ext uri="{FF2B5EF4-FFF2-40B4-BE49-F238E27FC236}">
                      <a16:creationId xmlns:a16="http://schemas.microsoft.com/office/drawing/2014/main" id="{322640DC-D613-87E7-9E33-DF795E126F0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317" y="2912"/>
                  <a:ext cx="0" cy="33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209" name="Rectangle 43">
                  <a:extLst>
                    <a:ext uri="{FF2B5EF4-FFF2-40B4-BE49-F238E27FC236}">
                      <a16:creationId xmlns:a16="http://schemas.microsoft.com/office/drawing/2014/main" id="{C1E374CF-1122-0D63-954C-350E854561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0" y="3031"/>
                  <a:ext cx="621" cy="1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l-GR" sz="16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</a:rPr>
                    <a:t>assay </a:t>
                  </a:r>
                  <a:r>
                    <a:rPr kumimoji="0" lang="el-GR" altLang="el-GR" sz="16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Palatino Linotype" panose="02040502050505030304" pitchFamily="18" charset="0"/>
                    </a:rPr>
                    <a:t>code</a:t>
                  </a:r>
                  <a:endParaRPr kumimoji="0" lang="el-GR" altLang="el-GR" sz="16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endParaRPr>
                </a:p>
              </p:txBody>
            </p:sp>
          </p:grpSp>
          <p:sp>
            <p:nvSpPr>
              <p:cNvPr id="6" name="Rectangle 42">
                <a:extLst>
                  <a:ext uri="{FF2B5EF4-FFF2-40B4-BE49-F238E27FC236}">
                    <a16:creationId xmlns:a16="http://schemas.microsoft.com/office/drawing/2014/main" id="{DE0628BD-9AE1-198B-43E6-D39972FB19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13554" y="4763589"/>
                <a:ext cx="34544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0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rPr>
                  <a:t>POX</a:t>
                </a:r>
                <a:endParaRPr kumimoji="0" lang="el-GR" altLang="el-G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0" name="Rectangle 38">
                <a:extLst>
                  <a:ext uri="{FF2B5EF4-FFF2-40B4-BE49-F238E27FC236}">
                    <a16:creationId xmlns:a16="http://schemas.microsoft.com/office/drawing/2014/main" id="{18E30E13-AD1C-ACDB-7F2D-15499CD905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92656" y="4723312"/>
                <a:ext cx="27732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</a:rPr>
                  <a:t>CAT</a:t>
                </a:r>
                <a:endParaRPr kumimoji="0" lang="el-GR" altLang="el-GR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1" name="Rectangle 34">
                <a:extLst>
                  <a:ext uri="{FF2B5EF4-FFF2-40B4-BE49-F238E27FC236}">
                    <a16:creationId xmlns:a16="http://schemas.microsoft.com/office/drawing/2014/main" id="{F293D60A-D7B6-6AAB-9F1E-CB97B9AA34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2917" y="4740729"/>
                <a:ext cx="29174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0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rPr>
                  <a:t>SOD</a:t>
                </a:r>
                <a:endParaRPr kumimoji="0" lang="el-GR" altLang="el-GR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2" name="Rectangle 31">
                <a:extLst>
                  <a:ext uri="{FF2B5EF4-FFF2-40B4-BE49-F238E27FC236}">
                    <a16:creationId xmlns:a16="http://schemas.microsoft.com/office/drawing/2014/main" id="{0C23F09E-0B59-E6D9-8DB1-F2A576C730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5254788" y="2834759"/>
                <a:ext cx="647678" cy="220717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600" b="1" dirty="0">
                    <a:solidFill>
                      <a:srgbClr val="000000"/>
                    </a:solidFill>
                    <a:effectLst/>
                    <a:latin typeface="Palatino Linotype" panose="0204050205050503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U /g</a:t>
                </a:r>
                <a:endParaRPr kumimoji="0" lang="el-GR" altLang="el-GR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44" name="TextBox 80">
              <a:extLst>
                <a:ext uri="{FF2B5EF4-FFF2-40B4-BE49-F238E27FC236}">
                  <a16:creationId xmlns:a16="http://schemas.microsoft.com/office/drawing/2014/main" id="{7A619223-F701-A915-F6CA-AA2DFCB42E79}"/>
                </a:ext>
              </a:extLst>
            </p:cNvPr>
            <p:cNvSpPr txBox="1"/>
            <p:nvPr/>
          </p:nvSpPr>
          <p:spPr>
            <a:xfrm>
              <a:off x="5267894" y="2625814"/>
              <a:ext cx="1212779" cy="434594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 algn="just">
                <a:lnSpc>
                  <a:spcPts val="1300"/>
                </a:lnSpc>
              </a:pPr>
              <a:r>
                <a:rPr lang="en-US" sz="1200" b="1" i="1" kern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p-</a:t>
              </a:r>
              <a:r>
                <a:rPr lang="en-US" sz="1200" b="1" kern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value = 0.905</a:t>
              </a:r>
              <a:r>
                <a:rPr lang="en-US" sz="1200" b="1" i="1" kern="12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 </a:t>
              </a:r>
              <a:endParaRPr lang="el-GR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98912347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Θέμα του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</TotalTime>
  <Words>31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Θέμα του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PAPAEFTHYMIOU MARIA</dc:creator>
  <cp:lastModifiedBy>MDPI</cp:lastModifiedBy>
  <cp:revision>2</cp:revision>
  <dcterms:created xsi:type="dcterms:W3CDTF">2024-03-21T05:35:56Z</dcterms:created>
  <dcterms:modified xsi:type="dcterms:W3CDTF">2024-06-04T12:26:54Z</dcterms:modified>
</cp:coreProperties>
</file>